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4"/>
  </p:sldMasterIdLst>
  <p:notesMasterIdLst>
    <p:notesMasterId r:id="rId6"/>
  </p:notesMasterIdLst>
  <p:sldIdLst>
    <p:sldId id="266" r:id="rId5"/>
  </p:sldIdLst>
  <p:sldSz cx="6858000" cy="9144000" type="screen4x3"/>
  <p:notesSz cx="6881813" cy="92964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60" autoAdjust="0"/>
    <p:restoredTop sz="94662"/>
  </p:normalViewPr>
  <p:slideViewPr>
    <p:cSldViewPr snapToGrid="0">
      <p:cViewPr varScale="1">
        <p:scale>
          <a:sx n="76" d="100"/>
          <a:sy n="76" d="100"/>
        </p:scale>
        <p:origin x="2682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iles Best" userId="37fc91ed-a70c-4176-a9f3-6c1d1b8162fa" providerId="ADAL" clId="{4B1C9C5E-1061-431E-8D36-DDBC914420DD}"/>
    <pc:docChg chg="delSld">
      <pc:chgData name="Giles Best" userId="37fc91ed-a70c-4176-a9f3-6c1d1b8162fa" providerId="ADAL" clId="{4B1C9C5E-1061-431E-8D36-DDBC914420DD}" dt="2020-12-07T02:28:30.046" v="0" actId="2696"/>
      <pc:docMkLst>
        <pc:docMk/>
      </pc:docMkLst>
      <pc:sldChg chg="del">
        <pc:chgData name="Giles Best" userId="37fc91ed-a70c-4176-a9f3-6c1d1b8162fa" providerId="ADAL" clId="{4B1C9C5E-1061-431E-8D36-DDBC914420DD}" dt="2020-12-07T02:28:30.046" v="0" actId="2696"/>
        <pc:sldMkLst>
          <pc:docMk/>
          <pc:sldMk cId="0" sldId="256"/>
        </pc:sldMkLst>
      </pc:sldChg>
      <pc:sldChg chg="del">
        <pc:chgData name="Giles Best" userId="37fc91ed-a70c-4176-a9f3-6c1d1b8162fa" providerId="ADAL" clId="{4B1C9C5E-1061-431E-8D36-DDBC914420DD}" dt="2020-12-07T02:28:30.046" v="0" actId="2696"/>
        <pc:sldMkLst>
          <pc:docMk/>
          <pc:sldMk cId="0" sldId="257"/>
        </pc:sldMkLst>
      </pc:sldChg>
      <pc:sldChg chg="del">
        <pc:chgData name="Giles Best" userId="37fc91ed-a70c-4176-a9f3-6c1d1b8162fa" providerId="ADAL" clId="{4B1C9C5E-1061-431E-8D36-DDBC914420DD}" dt="2020-12-07T02:28:30.046" v="0" actId="2696"/>
        <pc:sldMkLst>
          <pc:docMk/>
          <pc:sldMk cId="0" sldId="258"/>
        </pc:sldMkLst>
      </pc:sldChg>
      <pc:sldChg chg="del">
        <pc:chgData name="Giles Best" userId="37fc91ed-a70c-4176-a9f3-6c1d1b8162fa" providerId="ADAL" clId="{4B1C9C5E-1061-431E-8D36-DDBC914420DD}" dt="2020-12-07T02:28:30.046" v="0" actId="2696"/>
        <pc:sldMkLst>
          <pc:docMk/>
          <pc:sldMk cId="3668634823" sldId="269"/>
        </pc:sldMkLst>
      </pc:sldChg>
      <pc:sldChg chg="del">
        <pc:chgData name="Giles Best" userId="37fc91ed-a70c-4176-a9f3-6c1d1b8162fa" providerId="ADAL" clId="{4B1C9C5E-1061-431E-8D36-DDBC914420DD}" dt="2020-12-07T02:28:30.046" v="0" actId="2696"/>
        <pc:sldMkLst>
          <pc:docMk/>
          <pc:sldMk cId="739316224" sldId="271"/>
        </pc:sldMkLst>
      </pc:sldChg>
      <pc:sldChg chg="del">
        <pc:chgData name="Giles Best" userId="37fc91ed-a70c-4176-a9f3-6c1d1b8162fa" providerId="ADAL" clId="{4B1C9C5E-1061-431E-8D36-DDBC914420DD}" dt="2020-12-07T02:28:30.046" v="0" actId="2696"/>
        <pc:sldMkLst>
          <pc:docMk/>
          <pc:sldMk cId="481822174" sldId="272"/>
        </pc:sldMkLst>
      </pc:sldChg>
      <pc:sldChg chg="del">
        <pc:chgData name="Giles Best" userId="37fc91ed-a70c-4176-a9f3-6c1d1b8162fa" providerId="ADAL" clId="{4B1C9C5E-1061-431E-8D36-DDBC914420DD}" dt="2020-12-07T02:28:30.046" v="0" actId="2696"/>
        <pc:sldMkLst>
          <pc:docMk/>
          <pc:sldMk cId="2666843575" sldId="273"/>
        </pc:sldMkLst>
      </pc:sldChg>
      <pc:sldChg chg="del">
        <pc:chgData name="Giles Best" userId="37fc91ed-a70c-4176-a9f3-6c1d1b8162fa" providerId="ADAL" clId="{4B1C9C5E-1061-431E-8D36-DDBC914420DD}" dt="2020-12-07T02:28:30.046" v="0" actId="2696"/>
        <pc:sldMkLst>
          <pc:docMk/>
          <pc:sldMk cId="853199918" sldId="274"/>
        </pc:sldMkLst>
      </pc:sldChg>
      <pc:sldMasterChg chg="delSldLayout">
        <pc:chgData name="Giles Best" userId="37fc91ed-a70c-4176-a9f3-6c1d1b8162fa" providerId="ADAL" clId="{4B1C9C5E-1061-431E-8D36-DDBC914420DD}" dt="2020-12-07T02:28:30.046" v="0" actId="2696"/>
        <pc:sldMasterMkLst>
          <pc:docMk/>
          <pc:sldMasterMk cId="0" sldId="2147483659"/>
        </pc:sldMasterMkLst>
        <pc:sldLayoutChg chg="del">
          <pc:chgData name="Giles Best" userId="37fc91ed-a70c-4176-a9f3-6c1d1b8162fa" providerId="ADAL" clId="{4B1C9C5E-1061-431E-8D36-DDBC914420DD}" dt="2020-12-07T02:28:30.046" v="0" actId="2696"/>
          <pc:sldLayoutMkLst>
            <pc:docMk/>
            <pc:sldMasterMk cId="0" sldId="2147483659"/>
            <pc:sldLayoutMk cId="0" sldId="2147483649"/>
          </pc:sldLayoutMkLst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hape 3"/>
          <p:cNvSpPr>
            <a:spLocks noGrp="1" noRot="1" noChangeAspect="1"/>
          </p:cNvSpPr>
          <p:nvPr>
            <p:ph type="sldImg" idx="2"/>
          </p:nvPr>
        </p:nvSpPr>
        <p:spPr>
          <a:xfrm>
            <a:off x="1147175" y="697225"/>
            <a:ext cx="4588075" cy="3486150"/>
          </a:xfrm>
          <a:custGeom>
            <a:avLst/>
            <a:gdLst/>
            <a:ahLst/>
            <a:cxnLst/>
            <a:rect l="0" t="0" r="0" b="0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Shape 4"/>
          <p:cNvSpPr txBox="1">
            <a:spLocks noGrp="1"/>
          </p:cNvSpPr>
          <p:nvPr>
            <p:ph type="body" idx="1"/>
          </p:nvPr>
        </p:nvSpPr>
        <p:spPr>
          <a:xfrm>
            <a:off x="688175" y="4415775"/>
            <a:ext cx="5505425" cy="41833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/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33600" y="696913"/>
            <a:ext cx="2616200" cy="34861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Supplementary graphs. </a:t>
            </a:r>
          </a:p>
        </p:txBody>
      </p:sp>
    </p:spTree>
    <p:extLst>
      <p:ext uri="{BB962C8B-B14F-4D97-AF65-F5344CB8AC3E}">
        <p14:creationId xmlns:p14="http://schemas.microsoft.com/office/powerpoint/2010/main" val="22669381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Shape 12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Shape 13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Shape 14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Shape 75"/>
          <p:cNvSpPr txBox="1">
            <a:spLocks noGrp="1"/>
          </p:cNvSpPr>
          <p:nvPr>
            <p:ph type="title"/>
          </p:nvPr>
        </p:nvSpPr>
        <p:spPr>
          <a:xfrm rot="5400000">
            <a:off x="1842558" y="3495677"/>
            <a:ext cx="7802033" cy="1543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6" name="Shape 76"/>
          <p:cNvSpPr txBox="1">
            <a:spLocks noGrp="1"/>
          </p:cNvSpPr>
          <p:nvPr>
            <p:ph type="body" idx="1"/>
          </p:nvPr>
        </p:nvSpPr>
        <p:spPr>
          <a:xfrm rot="5400000">
            <a:off x="-1300692" y="2009777"/>
            <a:ext cx="7802033" cy="45148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7" name="Shape 77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8" name="Shape 78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9" name="Shape 79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Shape 22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3" name="Shape 23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4" name="Shape 24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5" name="Shape 25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6" name="Shape 26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Shape 28"/>
          <p:cNvSpPr txBox="1"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9" name="Shape 29"/>
          <p:cNvSpPr txBox="1"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Font typeface="Arial"/>
              <a:buNone/>
              <a:defRPr sz="18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Font typeface="Arial"/>
              <a:buNone/>
              <a:defRPr sz="16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Font typeface="Arial"/>
              <a:buNone/>
              <a:defRPr sz="14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0" name="Shape 30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1" name="Shape 31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2" name="Shape 32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Shape 34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35" name="Shape 35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6" name="Shape 36"/>
          <p:cNvSpPr txBox="1">
            <a:spLocks noGrp="1"/>
          </p:cNvSpPr>
          <p:nvPr>
            <p:ph type="body" idx="2"/>
          </p:nvPr>
        </p:nvSpPr>
        <p:spPr>
          <a:xfrm>
            <a:off x="3486150" y="2133601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–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–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»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7" name="Shape 37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8" name="Shape 38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39" name="Shape 39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hape 4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42" name="Shape 42"/>
          <p:cNvSpPr txBox="1"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3" name="Shape 43"/>
          <p:cNvSpPr txBox="1">
            <a:spLocks noGrp="1"/>
          </p:cNvSpPr>
          <p:nvPr>
            <p:ph type="body" idx="2"/>
          </p:nvPr>
        </p:nvSpPr>
        <p:spPr>
          <a:xfrm>
            <a:off x="342900" y="2899833"/>
            <a:ext cx="303014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4" name="Shape 44"/>
          <p:cNvSpPr txBox="1">
            <a:spLocks noGrp="1"/>
          </p:cNvSpPr>
          <p:nvPr>
            <p:ph type="body" idx="3"/>
          </p:nvPr>
        </p:nvSpPr>
        <p:spPr>
          <a:xfrm>
            <a:off x="3483769" y="2046817"/>
            <a:ext cx="303133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marR="0" lvl="0" indent="-2286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None/>
              <a:defRPr sz="16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5" name="Shape 45"/>
          <p:cNvSpPr txBox="1">
            <a:spLocks noGrp="1"/>
          </p:cNvSpPr>
          <p:nvPr>
            <p:ph type="body" idx="4"/>
          </p:nvPr>
        </p:nvSpPr>
        <p:spPr>
          <a:xfrm>
            <a:off x="3483769" y="2899833"/>
            <a:ext cx="303133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42900" algn="l" rtl="0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–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»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30200" algn="l" rtl="0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Font typeface="Arial"/>
              <a:buChar char="•"/>
              <a:defRPr sz="16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6" name="Shape 46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7" name="Shape 47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8" name="Shape 48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Shape 50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1" name="Shape 51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2" name="Shape 52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3" name="Shape 53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Shape 55"/>
          <p:cNvSpPr txBox="1"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56" name="Shape 56"/>
          <p:cNvSpPr txBox="1">
            <a:spLocks noGrp="1"/>
          </p:cNvSpPr>
          <p:nvPr>
            <p:ph type="body" idx="1"/>
          </p:nvPr>
        </p:nvSpPr>
        <p:spPr>
          <a:xfrm>
            <a:off x="2681287" y="364067"/>
            <a:ext cx="3833813" cy="7804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7" name="Shape 57"/>
          <p:cNvSpPr txBox="1">
            <a:spLocks noGrp="1"/>
          </p:cNvSpPr>
          <p:nvPr>
            <p:ph type="body" idx="2"/>
          </p:nvPr>
        </p:nvSpPr>
        <p:spPr>
          <a:xfrm>
            <a:off x="342900" y="1913467"/>
            <a:ext cx="2256235" cy="62547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8" name="Shape 5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9" name="Shape 5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0" name="Shape 6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Shape 62"/>
          <p:cNvSpPr txBox="1"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63" name="Shape 63"/>
          <p:cNvSpPr>
            <a:spLocks noGrp="1"/>
          </p:cNvSpPr>
          <p:nvPr>
            <p:ph type="pic" idx="2"/>
          </p:nvPr>
        </p:nvSpPr>
        <p:spPr>
          <a:xfrm>
            <a:off x="1344216" y="817033"/>
            <a:ext cx="4114800" cy="548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Shape 64"/>
          <p:cNvSpPr txBox="1">
            <a:spLocks noGrp="1"/>
          </p:cNvSpPr>
          <p:nvPr>
            <p:ph type="body" idx="1"/>
          </p:nvPr>
        </p:nvSpPr>
        <p:spPr>
          <a:xfrm>
            <a:off x="1344216" y="7156451"/>
            <a:ext cx="4114800" cy="10731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Font typeface="Arial"/>
              <a:buNone/>
              <a:defRPr sz="1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Font typeface="Arial"/>
              <a:buNone/>
              <a:defRPr sz="1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Font typeface="Arial"/>
              <a:buNone/>
              <a:defRPr sz="9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5" name="Shape 65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6" name="Shape 66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7" name="Shape 67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Shape 69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0" name="Shape 70"/>
          <p:cNvSpPr txBox="1">
            <a:spLocks noGrp="1"/>
          </p:cNvSpPr>
          <p:nvPr>
            <p:ph type="body" idx="1"/>
          </p:nvPr>
        </p:nvSpPr>
        <p:spPr>
          <a:xfrm rot="5400000">
            <a:off x="411692" y="2064809"/>
            <a:ext cx="6034617" cy="617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1" name="Shape 71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2" name="Shape 72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3" name="Shape 73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Shape 7"/>
          <p:cNvSpPr txBox="1"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Shape 8"/>
          <p:cNvSpPr txBox="1">
            <a:spLocks noGrp="1"/>
          </p:cNvSpPr>
          <p:nvPr>
            <p:ph type="dt" idx="10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Shape 9"/>
          <p:cNvSpPr txBox="1">
            <a:spLocks noGrp="1"/>
          </p:cNvSpPr>
          <p:nvPr>
            <p:ph type="ftr" idx="11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Shape 10"/>
          <p:cNvSpPr txBox="1">
            <a:spLocks noGrp="1"/>
          </p:cNvSpPr>
          <p:nvPr>
            <p:ph type="sldNum" idx="12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C65E225-CCDB-4D75-9355-A320DD323F8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388" t="8880" r="25182" b="27091"/>
          <a:stretch/>
        </p:blipFill>
        <p:spPr>
          <a:xfrm>
            <a:off x="1013460" y="1988020"/>
            <a:ext cx="2076751" cy="193576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490CAB0-A257-486A-884C-E79AC2134A9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363" t="7767" b="34033"/>
          <a:stretch/>
        </p:blipFill>
        <p:spPr>
          <a:xfrm>
            <a:off x="4198850" y="1940055"/>
            <a:ext cx="2570224" cy="1984245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C4A1C8F0-867F-4A04-995A-D0E47A7BE29B}"/>
              </a:ext>
            </a:extLst>
          </p:cNvPr>
          <p:cNvGrpSpPr/>
          <p:nvPr/>
        </p:nvGrpSpPr>
        <p:grpSpPr>
          <a:xfrm>
            <a:off x="4691064" y="2925785"/>
            <a:ext cx="738330" cy="78701"/>
            <a:chOff x="6086613" y="3770312"/>
            <a:chExt cx="831270" cy="84138"/>
          </a:xfrm>
        </p:grpSpPr>
        <p:cxnSp>
          <p:nvCxnSpPr>
            <p:cNvPr id="13" name="Shape 93">
              <a:extLst>
                <a:ext uri="{FF2B5EF4-FFF2-40B4-BE49-F238E27FC236}">
                  <a16:creationId xmlns:a16="http://schemas.microsoft.com/office/drawing/2014/main" id="{361CE7AE-BCE1-411D-91B7-363126447EC8}"/>
                </a:ext>
              </a:extLst>
            </p:cNvPr>
            <p:cNvCxnSpPr>
              <a:cxnSpLocks/>
            </p:cNvCxnSpPr>
            <p:nvPr/>
          </p:nvCxnSpPr>
          <p:spPr>
            <a:xfrm>
              <a:off x="6086613" y="3770312"/>
              <a:ext cx="0" cy="828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4" name="Shape 94">
              <a:extLst>
                <a:ext uri="{FF2B5EF4-FFF2-40B4-BE49-F238E27FC236}">
                  <a16:creationId xmlns:a16="http://schemas.microsoft.com/office/drawing/2014/main" id="{AEA11F6E-4F74-4B78-AB64-C076BD49D1A8}"/>
                </a:ext>
              </a:extLst>
            </p:cNvPr>
            <p:cNvCxnSpPr>
              <a:cxnSpLocks/>
            </p:cNvCxnSpPr>
            <p:nvPr/>
          </p:nvCxnSpPr>
          <p:spPr>
            <a:xfrm>
              <a:off x="6915614" y="3773487"/>
              <a:ext cx="0" cy="80963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5" name="Shape 97">
              <a:extLst>
                <a:ext uri="{FF2B5EF4-FFF2-40B4-BE49-F238E27FC236}">
                  <a16:creationId xmlns:a16="http://schemas.microsoft.com/office/drawing/2014/main" id="{9272C859-F4A5-4BA0-8861-8DCA4D06456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89883" y="3770312"/>
              <a:ext cx="828000" cy="3176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6EB82B12-6BB6-4B00-9B17-D484894743D5}"/>
              </a:ext>
            </a:extLst>
          </p:cNvPr>
          <p:cNvGrpSpPr/>
          <p:nvPr/>
        </p:nvGrpSpPr>
        <p:grpSpPr>
          <a:xfrm>
            <a:off x="4691064" y="2265900"/>
            <a:ext cx="1440196" cy="83857"/>
            <a:chOff x="6097183" y="3715375"/>
            <a:chExt cx="1621485" cy="89650"/>
          </a:xfrm>
        </p:grpSpPr>
        <p:cxnSp>
          <p:nvCxnSpPr>
            <p:cNvPr id="10" name="Shape 93">
              <a:extLst>
                <a:ext uri="{FF2B5EF4-FFF2-40B4-BE49-F238E27FC236}">
                  <a16:creationId xmlns:a16="http://schemas.microsoft.com/office/drawing/2014/main" id="{D2619B3B-13FF-4086-B1FA-E5F6FFDF3260}"/>
                </a:ext>
              </a:extLst>
            </p:cNvPr>
            <p:cNvCxnSpPr>
              <a:cxnSpLocks/>
            </p:cNvCxnSpPr>
            <p:nvPr/>
          </p:nvCxnSpPr>
          <p:spPr>
            <a:xfrm>
              <a:off x="6097183" y="3722225"/>
              <a:ext cx="0" cy="82800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1" name="Shape 94">
              <a:extLst>
                <a:ext uri="{FF2B5EF4-FFF2-40B4-BE49-F238E27FC236}">
                  <a16:creationId xmlns:a16="http://schemas.microsoft.com/office/drawing/2014/main" id="{C8F297F2-4E91-4A24-ADA9-A559BA2D9B8D}"/>
                </a:ext>
              </a:extLst>
            </p:cNvPr>
            <p:cNvCxnSpPr>
              <a:cxnSpLocks/>
            </p:cNvCxnSpPr>
            <p:nvPr/>
          </p:nvCxnSpPr>
          <p:spPr>
            <a:xfrm>
              <a:off x="7718668" y="3718551"/>
              <a:ext cx="0" cy="80963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  <p:cxnSp>
          <p:nvCxnSpPr>
            <p:cNvPr id="12" name="Shape 97">
              <a:extLst>
                <a:ext uri="{FF2B5EF4-FFF2-40B4-BE49-F238E27FC236}">
                  <a16:creationId xmlns:a16="http://schemas.microsoft.com/office/drawing/2014/main" id="{B871CBA8-8222-4728-8DB8-81892F8D4A6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97183" y="3715375"/>
              <a:ext cx="1620000" cy="3176"/>
            </a:xfrm>
            <a:prstGeom prst="straightConnector1">
              <a:avLst/>
            </a:prstGeom>
            <a:noFill/>
            <a:ln w="9525" cap="flat" cmpd="sng">
              <a:solidFill>
                <a:schemeClr val="dk1"/>
              </a:solidFill>
              <a:prstDash val="solid"/>
              <a:round/>
              <a:headEnd type="none" w="sm" len="sm"/>
              <a:tailEnd type="none" w="sm" len="sm"/>
            </a:ln>
          </p:spPr>
        </p:cxn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A03A748B-175E-4F23-A573-1A477B3BFAC7}"/>
              </a:ext>
            </a:extLst>
          </p:cNvPr>
          <p:cNvSpPr txBox="1"/>
          <p:nvPr/>
        </p:nvSpPr>
        <p:spPr>
          <a:xfrm>
            <a:off x="5244943" y="2079672"/>
            <a:ext cx="440378" cy="28788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***</a:t>
            </a:r>
          </a:p>
        </p:txBody>
      </p:sp>
      <p:sp>
        <p:nvSpPr>
          <p:cNvPr id="16" name="Shape 116">
            <a:extLst>
              <a:ext uri="{FF2B5EF4-FFF2-40B4-BE49-F238E27FC236}">
                <a16:creationId xmlns:a16="http://schemas.microsoft.com/office/drawing/2014/main" id="{DFA332AA-87D2-4231-AC79-2C3225116420}"/>
              </a:ext>
            </a:extLst>
          </p:cNvPr>
          <p:cNvSpPr txBox="1"/>
          <p:nvPr/>
        </p:nvSpPr>
        <p:spPr>
          <a:xfrm>
            <a:off x="0" y="756214"/>
            <a:ext cx="2542893" cy="2172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ry Figure 1</a:t>
            </a:r>
            <a:endParaRPr sz="18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556BBAD5-6F41-4CE1-8BFE-116AFEBE54BD}"/>
              </a:ext>
            </a:extLst>
          </p:cNvPr>
          <p:cNvSpPr/>
          <p:nvPr/>
        </p:nvSpPr>
        <p:spPr>
          <a:xfrm>
            <a:off x="88926" y="1230306"/>
            <a:ext cx="6680148" cy="4025921"/>
          </a:xfrm>
          <a:prstGeom prst="rect">
            <a:avLst/>
          </a:prstGeom>
          <a:noFill/>
          <a:ln w="12700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961D7F7-2A75-4505-884E-1BCE48CD0CFB}"/>
              </a:ext>
            </a:extLst>
          </p:cNvPr>
          <p:cNvSpPr txBox="1"/>
          <p:nvPr/>
        </p:nvSpPr>
        <p:spPr>
          <a:xfrm rot="16200000">
            <a:off x="3037082" y="2787285"/>
            <a:ext cx="15584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ONC-212 IC50 (nM)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9B0D33D0-6468-42AF-8532-5D1A353835F5}"/>
              </a:ext>
            </a:extLst>
          </p:cNvPr>
          <p:cNvSpPr/>
          <p:nvPr/>
        </p:nvSpPr>
        <p:spPr>
          <a:xfrm>
            <a:off x="5082540" y="1874520"/>
            <a:ext cx="762000" cy="3641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F697B17-187E-403F-B19A-B9AADCD1F2BF}"/>
              </a:ext>
            </a:extLst>
          </p:cNvPr>
          <p:cNvSpPr txBox="1"/>
          <p:nvPr/>
        </p:nvSpPr>
        <p:spPr>
          <a:xfrm>
            <a:off x="4970362" y="1996074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p</a:t>
            </a:r>
            <a:r>
              <a:rPr lang="en-AU" sz="1200" dirty="0"/>
              <a:t> = 0.0009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F704C3D-724E-4B38-B1A9-016BA958477A}"/>
              </a:ext>
            </a:extLst>
          </p:cNvPr>
          <p:cNvSpPr/>
          <p:nvPr/>
        </p:nvSpPr>
        <p:spPr>
          <a:xfrm>
            <a:off x="4815428" y="2578110"/>
            <a:ext cx="635557" cy="29761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9D3D8D4-A58E-436B-B07E-86CCC7DCB9B0}"/>
              </a:ext>
            </a:extLst>
          </p:cNvPr>
          <p:cNvSpPr txBox="1"/>
          <p:nvPr/>
        </p:nvSpPr>
        <p:spPr>
          <a:xfrm>
            <a:off x="4625523" y="2634732"/>
            <a:ext cx="9140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p</a:t>
            </a:r>
            <a:r>
              <a:rPr lang="en-AU" sz="1200" dirty="0"/>
              <a:t> = 0.285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4E76680-F734-4FAD-8B7D-31D64416DC51}"/>
              </a:ext>
            </a:extLst>
          </p:cNvPr>
          <p:cNvSpPr txBox="1"/>
          <p:nvPr/>
        </p:nvSpPr>
        <p:spPr>
          <a:xfrm>
            <a:off x="1670472" y="4364234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F68FB99-0973-4608-B921-30C191453D46}"/>
              </a:ext>
            </a:extLst>
          </p:cNvPr>
          <p:cNvSpPr txBox="1"/>
          <p:nvPr/>
        </p:nvSpPr>
        <p:spPr>
          <a:xfrm>
            <a:off x="1665872" y="477138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TP53</a:t>
            </a:r>
            <a:r>
              <a:rPr lang="en-AU" sz="1200" dirty="0"/>
              <a:t>ko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8942339-97C7-4CB7-98F2-F88BA6D9422E}"/>
              </a:ext>
            </a:extLst>
          </p:cNvPr>
          <p:cNvSpPr txBox="1"/>
          <p:nvPr/>
        </p:nvSpPr>
        <p:spPr>
          <a:xfrm>
            <a:off x="1674439" y="4569706"/>
            <a:ext cx="14157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Cas9 + </a:t>
            </a:r>
            <a:r>
              <a:rPr lang="en-AU" sz="1200" dirty="0" err="1"/>
              <a:t>guideRNA</a:t>
            </a:r>
            <a:endParaRPr lang="en-AU" sz="12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5D96574-E771-4C69-BA47-C9B6B1D812CB}"/>
              </a:ext>
            </a:extLst>
          </p:cNvPr>
          <p:cNvSpPr txBox="1"/>
          <p:nvPr/>
        </p:nvSpPr>
        <p:spPr>
          <a:xfrm>
            <a:off x="1400994" y="4020627"/>
            <a:ext cx="1576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Log [ONC-212] (nM)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482B8C7-9EE5-46D1-8841-D26E1DF0A029}"/>
              </a:ext>
            </a:extLst>
          </p:cNvPr>
          <p:cNvCxnSpPr/>
          <p:nvPr/>
        </p:nvCxnSpPr>
        <p:spPr>
          <a:xfrm>
            <a:off x="1387893" y="4499506"/>
            <a:ext cx="342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tangle 26">
            <a:extLst>
              <a:ext uri="{FF2B5EF4-FFF2-40B4-BE49-F238E27FC236}">
                <a16:creationId xmlns:a16="http://schemas.microsoft.com/office/drawing/2014/main" id="{EF889E0D-74E8-4A19-99BF-8F9857553A25}"/>
              </a:ext>
            </a:extLst>
          </p:cNvPr>
          <p:cNvSpPr/>
          <p:nvPr/>
        </p:nvSpPr>
        <p:spPr>
          <a:xfrm>
            <a:off x="1518068" y="4454134"/>
            <a:ext cx="82550" cy="93813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6829CE4D-7DAA-4D1D-838A-E3905E5F142A}"/>
              </a:ext>
            </a:extLst>
          </p:cNvPr>
          <p:cNvCxnSpPr/>
          <p:nvPr/>
        </p:nvCxnSpPr>
        <p:spPr>
          <a:xfrm>
            <a:off x="1387523" y="4713807"/>
            <a:ext cx="342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Oval 28">
            <a:extLst>
              <a:ext uri="{FF2B5EF4-FFF2-40B4-BE49-F238E27FC236}">
                <a16:creationId xmlns:a16="http://schemas.microsoft.com/office/drawing/2014/main" id="{5B7AA25D-546C-4CBB-9799-34EDC57D8AE0}"/>
              </a:ext>
            </a:extLst>
          </p:cNvPr>
          <p:cNvSpPr/>
          <p:nvPr/>
        </p:nvSpPr>
        <p:spPr>
          <a:xfrm>
            <a:off x="1520837" y="4671448"/>
            <a:ext cx="82550" cy="86218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2F82661-8F27-4DEC-A023-484BA93EBF2F}"/>
              </a:ext>
            </a:extLst>
          </p:cNvPr>
          <p:cNvCxnSpPr/>
          <p:nvPr/>
        </p:nvCxnSpPr>
        <p:spPr>
          <a:xfrm>
            <a:off x="1391152" y="4909887"/>
            <a:ext cx="342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Rectangle 30">
            <a:extLst>
              <a:ext uri="{FF2B5EF4-FFF2-40B4-BE49-F238E27FC236}">
                <a16:creationId xmlns:a16="http://schemas.microsoft.com/office/drawing/2014/main" id="{EF0A0EAF-9A7A-4393-9F53-48045DACEBE3}"/>
              </a:ext>
            </a:extLst>
          </p:cNvPr>
          <p:cNvSpPr/>
          <p:nvPr/>
        </p:nvSpPr>
        <p:spPr>
          <a:xfrm rot="2758136">
            <a:off x="1524894" y="4870784"/>
            <a:ext cx="78441" cy="7820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05F04FB-53B6-45AB-9258-B5FB0D9E06BE}"/>
              </a:ext>
            </a:extLst>
          </p:cNvPr>
          <p:cNvSpPr txBox="1"/>
          <p:nvPr/>
        </p:nvSpPr>
        <p:spPr>
          <a:xfrm rot="-2700000">
            <a:off x="4153693" y="4064573"/>
            <a:ext cx="809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OSU-W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23222ED-35AB-46FD-8AE3-744F6270E39A}"/>
              </a:ext>
            </a:extLst>
          </p:cNvPr>
          <p:cNvSpPr txBox="1"/>
          <p:nvPr/>
        </p:nvSpPr>
        <p:spPr>
          <a:xfrm rot="-2700000">
            <a:off x="4382297" y="4245707"/>
            <a:ext cx="14157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Cas9 + </a:t>
            </a:r>
            <a:r>
              <a:rPr lang="en-AU" sz="1200" dirty="0" err="1"/>
              <a:t>guideRNA</a:t>
            </a:r>
            <a:endParaRPr lang="en-AU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38FCAE5-FA43-44CF-AC9F-330F2668BE75}"/>
              </a:ext>
            </a:extLst>
          </p:cNvPr>
          <p:cNvSpPr txBox="1"/>
          <p:nvPr/>
        </p:nvSpPr>
        <p:spPr>
          <a:xfrm rot="-2700000">
            <a:off x="5692130" y="401075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i="1" dirty="0"/>
              <a:t>TP53</a:t>
            </a:r>
            <a:r>
              <a:rPr lang="en-AU" sz="1200" dirty="0"/>
              <a:t>ko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E1BAE96-89EB-446F-8AF0-6F8F5623425D}"/>
              </a:ext>
            </a:extLst>
          </p:cNvPr>
          <p:cNvSpPr txBox="1"/>
          <p:nvPr/>
        </p:nvSpPr>
        <p:spPr>
          <a:xfrm>
            <a:off x="793528" y="373227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506DA65-2572-4CA8-AF09-45E7C8AEA973}"/>
              </a:ext>
            </a:extLst>
          </p:cNvPr>
          <p:cNvSpPr txBox="1"/>
          <p:nvPr/>
        </p:nvSpPr>
        <p:spPr>
          <a:xfrm>
            <a:off x="722996" y="345459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2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D3CDB95-AD5B-4E4C-BCCA-F131FD0E1889}"/>
              </a:ext>
            </a:extLst>
          </p:cNvPr>
          <p:cNvSpPr txBox="1"/>
          <p:nvPr/>
        </p:nvSpPr>
        <p:spPr>
          <a:xfrm>
            <a:off x="723928" y="31702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4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8C7AD22-30FA-4F0A-98BA-83FC7793D4EB}"/>
              </a:ext>
            </a:extLst>
          </p:cNvPr>
          <p:cNvSpPr txBox="1"/>
          <p:nvPr/>
        </p:nvSpPr>
        <p:spPr>
          <a:xfrm>
            <a:off x="723928" y="28848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6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CD97704-BA79-4B18-8B3E-0AD3206B2EA4}"/>
              </a:ext>
            </a:extLst>
          </p:cNvPr>
          <p:cNvSpPr txBox="1"/>
          <p:nvPr/>
        </p:nvSpPr>
        <p:spPr>
          <a:xfrm>
            <a:off x="722996" y="25993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8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429C0ED-2977-4E56-9B91-3A6FC83DD372}"/>
              </a:ext>
            </a:extLst>
          </p:cNvPr>
          <p:cNvSpPr txBox="1"/>
          <p:nvPr/>
        </p:nvSpPr>
        <p:spPr>
          <a:xfrm>
            <a:off x="678039" y="2315534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10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84159F2-C822-4C23-8991-45EFB218ECE6}"/>
              </a:ext>
            </a:extLst>
          </p:cNvPr>
          <p:cNvSpPr txBox="1"/>
          <p:nvPr/>
        </p:nvSpPr>
        <p:spPr>
          <a:xfrm>
            <a:off x="678039" y="2019679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120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DD7E196-2094-4D9E-A663-5F39007B998B}"/>
              </a:ext>
            </a:extLst>
          </p:cNvPr>
          <p:cNvSpPr txBox="1"/>
          <p:nvPr/>
        </p:nvSpPr>
        <p:spPr>
          <a:xfrm>
            <a:off x="949103" y="389102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1EF3442-18A8-4959-83D5-7398B113977E}"/>
              </a:ext>
            </a:extLst>
          </p:cNvPr>
          <p:cNvSpPr txBox="1"/>
          <p:nvPr/>
        </p:nvSpPr>
        <p:spPr>
          <a:xfrm>
            <a:off x="1584743" y="388127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3ECFD14-DDA7-48F9-88FA-E03A0C209605}"/>
              </a:ext>
            </a:extLst>
          </p:cNvPr>
          <p:cNvSpPr txBox="1"/>
          <p:nvPr/>
        </p:nvSpPr>
        <p:spPr>
          <a:xfrm>
            <a:off x="2217815" y="387741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7B74454-1C83-42E7-BD4A-AB670C732357}"/>
              </a:ext>
            </a:extLst>
          </p:cNvPr>
          <p:cNvSpPr txBox="1"/>
          <p:nvPr/>
        </p:nvSpPr>
        <p:spPr>
          <a:xfrm>
            <a:off x="2859507" y="387741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B716F45-C986-47D0-89D1-90AE95E3BF77}"/>
              </a:ext>
            </a:extLst>
          </p:cNvPr>
          <p:cNvSpPr txBox="1"/>
          <p:nvPr/>
        </p:nvSpPr>
        <p:spPr>
          <a:xfrm rot="16200000">
            <a:off x="92376" y="2864734"/>
            <a:ext cx="9941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200" dirty="0"/>
              <a:t>Viability (%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AFBBA2D3-76B5-4AD3-B8B6-199CE9C5C08A}"/>
              </a:ext>
            </a:extLst>
          </p:cNvPr>
          <p:cNvSpPr txBox="1"/>
          <p:nvPr/>
        </p:nvSpPr>
        <p:spPr>
          <a:xfrm>
            <a:off x="3923126" y="31499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2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66E8271-8391-48A7-86BC-5DE671367F07}"/>
              </a:ext>
            </a:extLst>
          </p:cNvPr>
          <p:cNvSpPr txBox="1"/>
          <p:nvPr/>
        </p:nvSpPr>
        <p:spPr>
          <a:xfrm>
            <a:off x="3921656" y="25752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4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D6563C5-4CC9-46E9-9B72-DE79EA19C4B2}"/>
              </a:ext>
            </a:extLst>
          </p:cNvPr>
          <p:cNvSpPr txBox="1"/>
          <p:nvPr/>
        </p:nvSpPr>
        <p:spPr>
          <a:xfrm>
            <a:off x="3927887" y="20083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6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615F191-B71E-49FC-B350-0F0A779A8F9E}"/>
              </a:ext>
            </a:extLst>
          </p:cNvPr>
          <p:cNvSpPr txBox="1"/>
          <p:nvPr/>
        </p:nvSpPr>
        <p:spPr>
          <a:xfrm>
            <a:off x="4004102" y="3714523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000" dirty="0"/>
              <a:t>0</a:t>
            </a:r>
          </a:p>
        </p:txBody>
      </p:sp>
    </p:spTree>
    <p:extLst>
      <p:ext uri="{BB962C8B-B14F-4D97-AF65-F5344CB8AC3E}">
        <p14:creationId xmlns:p14="http://schemas.microsoft.com/office/powerpoint/2010/main" val="27142589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7B0E940A8679C4DB0C350D77CBCE854" ma:contentTypeVersion="12" ma:contentTypeDescription="Create a new document." ma:contentTypeScope="" ma:versionID="f5f9f7175881b13a889a0d639ab51912">
  <xsd:schema xmlns:xsd="http://www.w3.org/2001/XMLSchema" xmlns:xs="http://www.w3.org/2001/XMLSchema" xmlns:p="http://schemas.microsoft.com/office/2006/metadata/properties" xmlns:ns1="http://schemas.microsoft.com/sharepoint/v3" xmlns:ns3="3bb96924-b64e-44a5-8c61-909dd2ef6642" targetNamespace="http://schemas.microsoft.com/office/2006/metadata/properties" ma:root="true" ma:fieldsID="f511df6768a327b089a47130675ef9ac" ns1:_="" ns3:_="">
    <xsd:import namespace="http://schemas.microsoft.com/sharepoint/v3"/>
    <xsd:import namespace="3bb96924-b64e-44a5-8c61-909dd2ef6642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1:_ip_UnifiedCompliancePolicyProperties" minOccurs="0"/>
                <xsd:element ref="ns1:_ip_UnifiedCompliancePolicyUIAc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8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19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b96924-b64e-44a5-8c61-909dd2ef664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ip_UnifiedCompliancePolicyUIAction xmlns="http://schemas.microsoft.com/sharepoint/v3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E782EE57-5E99-4BC1-BEE3-30F62874DA66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040A23C-D790-4504-93E6-92BEC575448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http://schemas.microsoft.com/sharepoint/v3"/>
    <ds:schemaRef ds:uri="3bb96924-b64e-44a5-8c61-909dd2ef664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E908F4C-033C-460F-9212-91CA38332388}">
  <ds:schemaRefs>
    <ds:schemaRef ds:uri="http://schemas.microsoft.com/office/2006/metadata/properties"/>
    <ds:schemaRef ds:uri="http://schemas.microsoft.com/office/infopath/2007/PartnerControls"/>
    <ds:schemaRef ds:uri="http://schemas.microsoft.com/sharepoint/v3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7265</TotalTime>
  <Words>52</Words>
  <Application>Microsoft Office PowerPoint</Application>
  <PresentationFormat>On-screen Show (4:3)</PresentationFormat>
  <Paragraphs>2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les</dc:creator>
  <cp:lastModifiedBy>Giles Best</cp:lastModifiedBy>
  <cp:revision>44</cp:revision>
  <cp:lastPrinted>2019-06-03T03:54:25Z</cp:lastPrinted>
  <dcterms:modified xsi:type="dcterms:W3CDTF">2020-12-07T02:28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7B0E940A8679C4DB0C350D77CBCE854</vt:lpwstr>
  </property>
</Properties>
</file>